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480175" cy="71993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FC9826-C5F3-4994-BD87-8A58BF7BAA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23640" y="288720"/>
            <a:ext cx="583236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23640" y="1679040"/>
            <a:ext cx="58323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23640" y="4160880"/>
            <a:ext cx="58323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7C84FF-EE61-4694-930C-50B726F694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23640" y="288720"/>
            <a:ext cx="583236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23640" y="1679040"/>
            <a:ext cx="28461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312360" y="1679040"/>
            <a:ext cx="28461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23640" y="4160880"/>
            <a:ext cx="28461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312360" y="4160880"/>
            <a:ext cx="28461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957D18-A7FF-44B7-B707-57F6864447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23640" y="288720"/>
            <a:ext cx="583236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23640" y="1679040"/>
            <a:ext cx="18777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95720" y="1679040"/>
            <a:ext cx="18777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267800" y="1679040"/>
            <a:ext cx="18777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23640" y="4160880"/>
            <a:ext cx="18777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95720" y="4160880"/>
            <a:ext cx="18777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267800" y="4160880"/>
            <a:ext cx="18777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991353-EDCA-4B65-9A7B-4D39820239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23640" y="288720"/>
            <a:ext cx="583236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23640" y="1679040"/>
            <a:ext cx="5832360" cy="4751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5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5B1E77-0883-4CAF-BB94-C50DB31D3D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23640" y="288720"/>
            <a:ext cx="583236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23640" y="1679040"/>
            <a:ext cx="5832360" cy="47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B0542D-AD7B-4EBC-ABAE-C4F4D6F6B5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23640" y="288720"/>
            <a:ext cx="583236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23640" y="1679040"/>
            <a:ext cx="2846160" cy="47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312360" y="1679040"/>
            <a:ext cx="2846160" cy="47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71F193-D548-43A1-A77E-AC6A6F0493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23640" y="288720"/>
            <a:ext cx="583236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AD168A-DE0A-41DE-AAA3-AD9C34AF6A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23640" y="288720"/>
            <a:ext cx="5832360" cy="5556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DFDE92-3087-49B9-B520-0EA385001E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23640" y="288720"/>
            <a:ext cx="583236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23640" y="1679040"/>
            <a:ext cx="28461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312360" y="1679040"/>
            <a:ext cx="2846160" cy="47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23640" y="4160880"/>
            <a:ext cx="28461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5DE5D-FD2D-4FBA-AB13-093D337069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23640" y="288720"/>
            <a:ext cx="583236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23640" y="1679040"/>
            <a:ext cx="2846160" cy="47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312360" y="1679040"/>
            <a:ext cx="28461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312360" y="4160880"/>
            <a:ext cx="28461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1F896-9868-42DD-BF1A-DFE161AB43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23640" y="288720"/>
            <a:ext cx="583236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23640" y="1679040"/>
            <a:ext cx="28461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312360" y="1679040"/>
            <a:ext cx="28461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23640" y="4160880"/>
            <a:ext cx="5832360" cy="226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20E823-0473-4289-A7F2-63AF9CF40F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23640" y="288720"/>
            <a:ext cx="583236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23640" y="1679040"/>
            <a:ext cx="5832360" cy="47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43000" indent="-24300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1" marL="525600" indent="-20160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2" marL="809640" indent="-16200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3" marL="1133640" indent="-16200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4" marL="1457280" indent="-16200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5" marL="1457280" indent="-16200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6" marL="1457280" indent="-16200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24000" y="6671880"/>
            <a:ext cx="1512720" cy="384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14360" y="6671880"/>
            <a:ext cx="2050920" cy="384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642920" y="6671880"/>
            <a:ext cx="1513080" cy="384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BE0F62-FFCD-4607-AF7D-ED570C24DBBB}" type="slidenum">
              <a:rPr b="0" lang="it-IT" sz="8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magine 3" descr=""/>
          <p:cNvPicPr/>
          <p:nvPr/>
        </p:nvPicPr>
        <p:blipFill>
          <a:blip r:embed="rId1"/>
          <a:stretch/>
        </p:blipFill>
        <p:spPr>
          <a:xfrm>
            <a:off x="719280" y="790560"/>
            <a:ext cx="4017960" cy="4884840"/>
          </a:xfrm>
          <a:prstGeom prst="rect">
            <a:avLst/>
          </a:prstGeom>
          <a:ln w="0">
            <a:noFill/>
          </a:ln>
        </p:spPr>
      </p:pic>
      <p:sp>
        <p:nvSpPr>
          <p:cNvPr id="42" name="ZoneTexte 2"/>
          <p:cNvSpPr/>
          <p:nvPr/>
        </p:nvSpPr>
        <p:spPr>
          <a:xfrm>
            <a:off x="4762080" y="1727280"/>
            <a:ext cx="99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Oleurope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ZoneTexte 3"/>
          <p:cNvSpPr/>
          <p:nvPr/>
        </p:nvSpPr>
        <p:spPr>
          <a:xfrm>
            <a:off x="4747680" y="4084560"/>
            <a:ext cx="9928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Oleurope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aglycon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ZoneTexte 2"/>
          <p:cNvSpPr/>
          <p:nvPr/>
        </p:nvSpPr>
        <p:spPr>
          <a:xfrm>
            <a:off x="5484240" y="0"/>
            <a:ext cx="990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</a:rPr>
              <a:t>SUPP FIG.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ectangle 1"/>
          <p:cNvSpPr/>
          <p:nvPr/>
        </p:nvSpPr>
        <p:spPr>
          <a:xfrm>
            <a:off x="1440" y="6599160"/>
            <a:ext cx="647856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Calibri"/>
              </a:rPr>
              <a:t>Supplemental Figure 1</a:t>
            </a: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: Top: Oleuropein in DMSO after  at 539 m/z and the [M+ Cl-] ion;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Bottom: the pellet redissolved in DMSO with 377 m/z as main ion corresponding to oleuropein aglycone.  The absence of the ion at 539 m/z  confirmed the complete hydrolysis of the glycated form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ectangle 2"/>
          <p:cNvSpPr/>
          <p:nvPr/>
        </p:nvSpPr>
        <p:spPr>
          <a:xfrm rot="19824000">
            <a:off x="4336560" y="688680"/>
            <a:ext cx="64260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glycated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for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7" name="Connecteur droit avec flèche 4"/>
          <p:cNvCxnSpPr/>
          <p:nvPr/>
        </p:nvCxnSpPr>
        <p:spPr>
          <a:xfrm flipH="1">
            <a:off x="4103280" y="934920"/>
            <a:ext cx="289440" cy="207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5-29T01:19:46Z</dcterms:created>
  <dc:creator>caterina miceli</dc:creator>
  <dc:description/>
  <dc:language>en-US</dc:language>
  <cp:lastModifiedBy>parini</cp:lastModifiedBy>
  <dcterms:modified xsi:type="dcterms:W3CDTF">2018-01-19T15:13:36Z</dcterms:modified>
  <cp:revision>31</cp:revision>
  <dc:subject/>
  <dc:title>Presentazione standard di PowerPoint</dc:title>
</cp:coreProperties>
</file>